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81079" autoAdjust="0"/>
  </p:normalViewPr>
  <p:slideViewPr>
    <p:cSldViewPr snapToGrid="0">
      <p:cViewPr varScale="1">
        <p:scale>
          <a:sx n="106" d="100"/>
          <a:sy n="106" d="100"/>
        </p:scale>
        <p:origin x="47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2DE309-69C0-4863-AEA6-A94EF8E265F7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3AA22F-B494-4907-BA15-064B38F6BB5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3501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/>
              <a:t>CY </a:t>
            </a:r>
            <a:r>
              <a:rPr lang="en-US" altLang="ko-KR" dirty="0"/>
              <a:t>vs. ETO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3AA22F-B494-4907-BA15-064B38F6BB5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156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157D23-D596-40AC-B397-6CCD7D9415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FDC8B61-4755-4119-84B0-6C65A9F88D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E247E8-8B4A-4863-A075-30341B2F4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3735AD-8955-4183-B19C-F661882CE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DB4DBC-9FEA-44D6-9D1E-0D8BBDFB8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5455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887862-19F4-4589-8769-10FBCF206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7617473-4015-449E-8C08-922AF1A795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FFFAFD-EF06-4D11-970F-76295B5DB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F86DC6F-6603-4E2F-825A-C1705C5CE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CF7C78-4745-4A60-B2A8-8B2053DE9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200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7823DD8-AB8C-400F-B5FB-A5DA6433EA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D2FC0F3-516C-4B94-8672-0B473FCC09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360FE96-3204-465E-9A47-C9455E06A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959A7A0-C515-4A30-9547-02AA65AB3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BFBD191-4B42-4487-81B9-D00A1FF64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17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5B02E6-0F11-4B87-B7FF-41509A5ED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7D7F634-E16B-4A73-B586-B01BDDD1A7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8829E2-9E1E-4D4C-B900-07410CFF1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1282967-9584-42A0-8885-950A257F8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3A33496-9B4B-485A-911D-1ACF5D7DD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251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2755AD-B08F-40AE-939B-9F7AEE1682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192E20E-2B7B-415C-8D36-938FA47DF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85EAA2-59FC-46D8-BD7E-280C90896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1BAD5D-D82C-47D0-BBF5-0075B0BAE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A9EF3AC-1266-43D7-9E4D-8E91682A5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2672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117AEA-CC7A-4C62-A9EC-0A1C87371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FF391B1-75E6-49E0-832D-AE71E4061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2E70D89-604B-4822-9690-48135785A0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D9D3F52-8850-4117-880D-7F4B5C913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E1FBCAC-396C-46E4-8AA1-4C075DD61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B1D130-6926-414E-94B1-E131212EC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6015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197E12-9A0C-468E-8AB5-D8710A7F4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71B0062-CA54-4819-B8AB-33DD47A1CD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75DABCC-CF6C-4CF3-AA00-E4D311AA5F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A791CFC-C4BB-4A98-A752-73257B86D9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222D344-EF7B-44B5-87B2-AF05CA1E84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10026A5-69C6-4003-8E50-BD84F6210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027292D-AD75-4226-BB10-0F0CA38A9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D056118-1FB7-4770-A3FD-7780013BE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92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C17A6A-0C28-4823-9BCA-E0DB47054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4E40CD8-3826-470A-BA74-C4A03CACC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079ED21-AF87-4060-8DC2-0B7E2783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C4C77E9-EF99-4552-8CF6-C7BB6D20B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231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5280C0C-606A-4CFF-8A2F-48E2ECD9A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19F27C1-E8E9-4CC5-A1E9-510595604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CCABE7E-5321-429B-9EDE-656DF8FAA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7354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B5A315-E5B3-425F-800F-6499F6E5C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8BF7889-9A91-420F-98F9-F488D0118A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9D4B7F0-140C-4E22-A0C9-42747F90E3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9499530-265F-4046-A89B-1F7162FE8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1E45E69-C097-4BE2-BF9E-2D60244DC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AEE3752-802F-4B37-AE6F-72B3149F2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0763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6FFC73-29ED-4586-ACCF-B525F802E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3EC9F01-5778-4EE9-A339-3D5E23D4C4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CAFEDB3-69CD-47EA-BA3C-F96A10748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C4D913-A788-4CAD-AEB6-9C5D3E628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88E2E4E-C916-4914-9B40-5EBE04897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939188-44E8-4B3C-8727-2F39F263D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731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283F88E-17E8-4DF5-B9B5-95832446D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D9DC328-8AE5-40F9-8EDC-2536AC358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4E7E8EA-BDEE-4C39-BE15-C40B875325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ED055-54F1-4D7F-9107-C8D49FD6DB90}" type="datetimeFigureOut">
              <a:rPr lang="ko-KR" altLang="en-US" smtClean="0"/>
              <a:t>2020-01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04AEB1-E7A7-44B7-ABF5-3233BA2571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157F9BD-E586-4CB9-9241-8E6DB9902F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4009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FC67ACB6-1BEC-4280-8A4B-432FB503CF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2427" y="0"/>
            <a:ext cx="6858000" cy="685800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BE9C3AD7-2AEB-4DC9-86DF-D252CD801D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0426" y="2930013"/>
            <a:ext cx="2333073" cy="373625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950392" y="192596"/>
            <a:ext cx="2919223" cy="1067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latinLnBrk="0" hangingPunct="0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. </a:t>
            </a:r>
            <a:r>
              <a:rPr lang="en-US" altLang="ko-K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twork analysis of cytokines in the mouse cytokine assay showing a significant (</a:t>
            </a:r>
            <a:r>
              <a:rPr lang="en-US" altLang="ko-KR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increase in the etoposide + G-CSF group compared to that in 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clophosphamide + G-CSF group</a:t>
            </a:r>
            <a:endParaRPr lang="en-US" altLang="ko-K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0296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</TotalTime>
  <Words>42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-won Kang</dc:creator>
  <cp:lastModifiedBy>Administrator</cp:lastModifiedBy>
  <cp:revision>20</cp:revision>
  <dcterms:created xsi:type="dcterms:W3CDTF">2019-06-10T02:34:07Z</dcterms:created>
  <dcterms:modified xsi:type="dcterms:W3CDTF">2020-01-08T04:50:09Z</dcterms:modified>
</cp:coreProperties>
</file>